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7" d="100"/>
          <a:sy n="87" d="100"/>
        </p:scale>
        <p:origin x="52" y="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1BF01A2-6A45-87B4-B81D-26F33E322D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76C2F5B-AF3E-986E-D51F-BAAB3377A17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E961672-AB69-1ABE-457B-EE4718A2AA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4AFDE-158F-4526-9DBE-DE54482F9C33}" type="datetimeFigureOut">
              <a:rPr lang="zh-CN" altLang="en-US" smtClean="0"/>
              <a:t>2024/1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A948B0F-E443-5B3A-4F63-0E2FC0A781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48296E2-3FF4-098C-E115-072672612B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43D2A-63F8-4DBE-825C-6BD480C288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518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E56D08-7F74-C39A-ACF3-5176165A9C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4677D8B-8FEC-22AC-51C1-B643DD7176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0E47D32-04FF-D778-BA1D-B568CB168A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4AFDE-158F-4526-9DBE-DE54482F9C33}" type="datetimeFigureOut">
              <a:rPr lang="zh-CN" altLang="en-US" smtClean="0"/>
              <a:t>2024/1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166FB4D-3CF8-E8CC-3730-6E26B10D32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2CA2A01-2064-9B50-DABC-FE52D4A99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43D2A-63F8-4DBE-825C-6BD480C288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96001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F16566C-1BF0-B480-9E65-9A28FBD0D7F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C8AE3A1-A022-D8AB-A6DB-530D57B568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8CD5EA8-1F4C-36EB-F91F-D142D1179D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4AFDE-158F-4526-9DBE-DE54482F9C33}" type="datetimeFigureOut">
              <a:rPr lang="zh-CN" altLang="en-US" smtClean="0"/>
              <a:t>2024/1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20B28DA-44D2-223E-DF56-C4905E8C4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2C5F9AB-9B76-6027-A312-46FA39814D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43D2A-63F8-4DBE-825C-6BD480C288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46880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12DF048-BC24-EC3A-1590-1263BDC395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D0C836A-25C7-2484-9B46-9CACA303D3A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330146-6B74-2ABF-21ED-19C86B420E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4AFDE-158F-4526-9DBE-DE54482F9C33}" type="datetimeFigureOut">
              <a:rPr lang="zh-CN" altLang="en-US" smtClean="0"/>
              <a:t>2024/1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FE2D719-687E-0571-6FE1-8B0F35327C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B19CB19-CC57-ADB3-9D05-E94FEAC18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43D2A-63F8-4DBE-825C-6BD480C288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6168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73F977C-5833-BD02-7299-41FB11C2EB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5BC190A-72E6-9CFC-DDDE-2655849FEFE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4AD0E46-2C1B-6681-3802-E36C92322C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4AFDE-158F-4526-9DBE-DE54482F9C33}" type="datetimeFigureOut">
              <a:rPr lang="zh-CN" altLang="en-US" smtClean="0"/>
              <a:t>2024/1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24D3A0-CF64-2903-610D-98146671DF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BE9F16C-A562-D9E4-2AE9-00AEEA507A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43D2A-63F8-4DBE-825C-6BD480C288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1713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37E419-6B64-C38D-5B7C-C5AF29A1B5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8EEC4D2-DD84-6FFF-F97A-FD591590C8A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ECDFC61-D7ED-526B-B035-C1BED14E40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3925A87-AB23-4296-FA0F-2865293301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4AFDE-158F-4526-9DBE-DE54482F9C33}" type="datetimeFigureOut">
              <a:rPr lang="zh-CN" altLang="en-US" smtClean="0"/>
              <a:t>2024/11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BBAC851-604F-B5A9-F80C-51E63F1C8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70C78F7-C25A-6C44-A06B-697CE6787E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43D2A-63F8-4DBE-825C-6BD480C288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46154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B12EAF9-2526-400C-70C1-ECA03A2F91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30CBCB-5C65-3C86-3467-182D8A17D2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AF22A81-0DBB-7BDD-2E26-C85CBD8887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C0820D8-2DED-3258-22EE-845CD86C0A8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6F20EE8-7664-78D7-CEC9-68B84D92CC5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D0F2D07-5B81-F27A-219D-C187BD7409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4AFDE-158F-4526-9DBE-DE54482F9C33}" type="datetimeFigureOut">
              <a:rPr lang="zh-CN" altLang="en-US" smtClean="0"/>
              <a:t>2024/11/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A9EF535B-7F6D-7EE2-377F-413FFAC032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EC65A4D-0D19-007C-72C3-D96CEBB27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43D2A-63F8-4DBE-825C-6BD480C288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78970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8B12D49-D965-4C9D-D08A-D2D22FC71D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07C405D0-B063-8131-A0D5-C4BAA30FDF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4AFDE-158F-4526-9DBE-DE54482F9C33}" type="datetimeFigureOut">
              <a:rPr lang="zh-CN" altLang="en-US" smtClean="0"/>
              <a:t>2024/11/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CFA07B93-1EED-1772-6B3D-866DBB34BA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46B26DB-4CC2-3350-E932-6F0FA90FD0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43D2A-63F8-4DBE-825C-6BD480C288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1534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8DE924CA-7429-FFBF-7093-426F8E8FF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4AFDE-158F-4526-9DBE-DE54482F9C33}" type="datetimeFigureOut">
              <a:rPr lang="zh-CN" altLang="en-US" smtClean="0"/>
              <a:t>2024/11/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C61C47A-5CAF-5C88-35B2-F804BA18CB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A34ACD25-0C23-AE94-6891-B0068C66F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43D2A-63F8-4DBE-825C-6BD480C288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52154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EA7632-2E17-A423-D7AF-939BCF02F1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E6434A1-5E9A-3886-3925-4F899D73D93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D10E494-079C-08A1-75F9-0CC8309821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E90C37C-ADF8-39C2-F91F-664963BAEE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4AFDE-158F-4526-9DBE-DE54482F9C33}" type="datetimeFigureOut">
              <a:rPr lang="zh-CN" altLang="en-US" smtClean="0"/>
              <a:t>2024/11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FD9D2F3-7816-2D97-3E99-4BA90DB4A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4755DA6-E4E4-2C5D-FD9C-86D1B4802D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43D2A-63F8-4DBE-825C-6BD480C288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03988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926DED0-9EDB-7F6A-4DF0-593BC759CF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3DCD262-1C8D-C5E5-AF61-C95069CDB96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98C30D1-2061-ED05-BC54-24EE043F3A6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456146B-2C87-C8CB-07F6-B3085428E7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4AFDE-158F-4526-9DBE-DE54482F9C33}" type="datetimeFigureOut">
              <a:rPr lang="zh-CN" altLang="en-US" smtClean="0"/>
              <a:t>2024/11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8B99F8F-0509-8648-11D0-A2EF178ACB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75A7EF5-BEFB-EDBD-1593-8126318F7C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943D2A-63F8-4DBE-825C-6BD480C288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3288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B6DE17E-B65B-2B15-A7EA-4B662C1653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BA5F3E9-A423-35C3-973C-E307644986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5224876-B884-4F3D-15A3-73A6601226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34AFDE-158F-4526-9DBE-DE54482F9C33}" type="datetimeFigureOut">
              <a:rPr lang="zh-CN" altLang="en-US" smtClean="0"/>
              <a:t>2024/11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ABCCEF4-5879-FE66-ABA7-84A10F608E7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C3AB93E-B034-0897-2D88-DFB4323F6EB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9943D2A-63F8-4DBE-825C-6BD480C288C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2129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0.png"/><Relationship Id="rId4" Type="http://schemas.openxmlformats.org/officeDocument/2006/relationships/image" Target="../media/image19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CF9627B-6976-04F6-2004-786C5F127884}"/>
              </a:ext>
            </a:extLst>
          </p:cNvPr>
          <p:cNvSpPr txBox="1"/>
          <p:nvPr/>
        </p:nvSpPr>
        <p:spPr>
          <a:xfrm>
            <a:off x="0" y="0"/>
            <a:ext cx="76628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xposure: Gout; Outcome: Heel bone mineral density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CC8D4F36-30FF-6150-B97F-A0DF1ECB542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99278" y="359175"/>
            <a:ext cx="2587662" cy="265358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3C5D4E10-72EB-DBF6-11B2-BF7B443EA0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22863" y="359175"/>
            <a:ext cx="2851912" cy="2936682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4E133B1D-ADB4-F466-A7DD-55D8906BF39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66751" y="3350199"/>
            <a:ext cx="3025532" cy="3148626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95ED0A9B-BFE0-8524-C3F4-F1C63C97E76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22863" y="3429000"/>
            <a:ext cx="3181393" cy="32958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39304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D012AC2-0FC1-207B-5B3D-63F31561882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CB07F824-F1C8-8FBB-59B6-D1F6A67EBA0E}"/>
              </a:ext>
            </a:extLst>
          </p:cNvPr>
          <p:cNvSpPr txBox="1"/>
          <p:nvPr/>
        </p:nvSpPr>
        <p:spPr>
          <a:xfrm>
            <a:off x="0" y="0"/>
            <a:ext cx="76628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xposure: Heel bone mineral density  Outcome: Gout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6EED2109-16BF-7E2D-338A-A1439CFC45E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81834" y="582648"/>
            <a:ext cx="4021925" cy="2846352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65F6328-6F15-64BD-409E-AAC50DF4258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34771" y="536360"/>
            <a:ext cx="3970251" cy="2867882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63D0ED10-ABA1-9255-F44C-A08BCA67184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51252" y="3893255"/>
            <a:ext cx="3957333" cy="2859270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EA680634-6ABC-2483-5EF3-E2C0A682C0F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66052" y="3644538"/>
            <a:ext cx="4021925" cy="29324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28734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696CE63-9B9A-EBB5-689B-ADCA9042418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7F316F6-7B78-73A3-9D45-27426F9E0AB2}"/>
              </a:ext>
            </a:extLst>
          </p:cNvPr>
          <p:cNvSpPr txBox="1"/>
          <p:nvPr/>
        </p:nvSpPr>
        <p:spPr>
          <a:xfrm>
            <a:off x="1" y="65331"/>
            <a:ext cx="61382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xposure: Gout; Outcome: BMI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4F25FA7-F5C1-737C-E6AE-3753A4BE07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13453" y="384049"/>
            <a:ext cx="3052107" cy="3119932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2EA0777-B1C4-3EBB-951A-7F720F6B09B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94493" y="468174"/>
            <a:ext cx="2973337" cy="3119932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493700BE-3B6A-3C13-98DE-CA87080ADC1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46311" y="3588106"/>
            <a:ext cx="3013681" cy="3119932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F84C3CAB-F354-D911-0A2E-133C625998F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36143" y="3588106"/>
            <a:ext cx="2969997" cy="31199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259421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3372C72-27F1-99A8-B560-233E614E5E3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4CFB641-1499-A6EC-2BB4-B5B35D7DB645}"/>
              </a:ext>
            </a:extLst>
          </p:cNvPr>
          <p:cNvSpPr txBox="1"/>
          <p:nvPr/>
        </p:nvSpPr>
        <p:spPr>
          <a:xfrm>
            <a:off x="0" y="0"/>
            <a:ext cx="76628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xposure: BMI Outcome: Gout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8658B28-8100-F8D5-FF22-F507C05AF8E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96668" y="307777"/>
            <a:ext cx="4102234" cy="289260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2FB6FABF-6B26-410E-6A12-2BD47C7729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29335" y="373348"/>
            <a:ext cx="4089085" cy="2905749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6B515C5F-D269-C0AE-AD06-9E223E34292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96668" y="3726958"/>
            <a:ext cx="4027727" cy="2932045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146AC995-7B2F-84C6-A0F8-C1C3C998520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982529" y="3574520"/>
            <a:ext cx="4080320" cy="29101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66847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BC37263-0065-C3F5-8DD9-D5EF293131A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E0999BF5-AED7-3520-F50F-90AD217812EA}"/>
              </a:ext>
            </a:extLst>
          </p:cNvPr>
          <p:cNvSpPr txBox="1"/>
          <p:nvPr/>
        </p:nvSpPr>
        <p:spPr>
          <a:xfrm>
            <a:off x="0" y="0"/>
            <a:ext cx="76628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xposure: Gout  Outcome: Alcohol consumption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30155F6-DE45-8161-0A3A-DEAE7C0699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7523" y="153888"/>
            <a:ext cx="3002654" cy="3114455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63E3A058-64F7-BD28-11F7-167A72B198F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96361" y="251866"/>
            <a:ext cx="3024831" cy="3114456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35199D5A-6046-EE53-1A04-C4743D6ADF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31421" y="3574754"/>
            <a:ext cx="2999578" cy="3114455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BD12BC32-5B5E-33CD-2836-2B0DF92B862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491676" y="3618188"/>
            <a:ext cx="2993444" cy="31144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34341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9E65DC6-464E-F455-FD50-25600835EC6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94AB6B8E-E60E-85CA-7C46-35C29B1504EF}"/>
              </a:ext>
            </a:extLst>
          </p:cNvPr>
          <p:cNvSpPr txBox="1"/>
          <p:nvPr/>
        </p:nvSpPr>
        <p:spPr>
          <a:xfrm>
            <a:off x="0" y="0"/>
            <a:ext cx="766284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xposure:   Outcome: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8208617-5C4F-65C2-F45E-D0762AE5A0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1522" y="340918"/>
            <a:ext cx="4142762" cy="2933357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C4B03D08-BBE8-AF44-E64A-81EF00888E6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30872" y="219456"/>
            <a:ext cx="4129569" cy="295974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E329429-C8A1-A633-ED8D-0D6151A0767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76433" y="3601316"/>
            <a:ext cx="4133967" cy="291576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E8731F7E-4CF0-B1B7-E73A-9C005CDFBC7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62532" y="3733762"/>
            <a:ext cx="4103182" cy="29333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423680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9</TotalTime>
  <Words>43</Words>
  <Application>Microsoft Office PowerPoint</Application>
  <PresentationFormat>宽屏</PresentationFormat>
  <Paragraphs>6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Yiwen TAO (20617230)</dc:creator>
  <cp:lastModifiedBy>Yiwen TAO (20617230)</cp:lastModifiedBy>
  <cp:revision>3</cp:revision>
  <dcterms:created xsi:type="dcterms:W3CDTF">2024-11-04T19:39:30Z</dcterms:created>
  <dcterms:modified xsi:type="dcterms:W3CDTF">2024-11-04T21:18:55Z</dcterms:modified>
</cp:coreProperties>
</file>